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CDFB8-637D-41EC-B925-0828ED35F2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1A863-351F-4EFE-BFFC-196117D775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988147-1623-4C9C-8214-EEA212E359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534FD-C96C-4638-B6BC-EBE2DBC4C8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B9EBC-0672-4996-95C2-982F3B70DC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5AF56F-9989-4063-966E-1D74471853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2BE75-1F2A-4368-8A60-68BFB381D1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184708-CCA1-4D2F-9E83-119B6F69B1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F4B1F-DDAD-4C94-984F-1B8031DA1C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14EF3-EA22-462C-9A1B-B954C0AD0D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88A8A-92F6-41C8-8D76-95BFAA3B0A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F165E-A0A1-4438-BB75-1FFDC21104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36BBFA-CB97-4613-9845-544F649E0E41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1880"/>
          <p:cNvSpPr/>
          <p:nvPr/>
        </p:nvSpPr>
        <p:spPr>
          <a:xfrm>
            <a:off x="1557360" y="2708280"/>
            <a:ext cx="26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979"/>
          <p:cNvSpPr/>
          <p:nvPr/>
        </p:nvSpPr>
        <p:spPr>
          <a:xfrm>
            <a:off x="297000" y="5634000"/>
            <a:ext cx="85057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1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limp-1, miR23a and miR125b expression in TNF-</a:t>
            </a:r>
            <a:r>
              <a:rPr b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-activated IL-4 D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 Blimp-1 expression was analyzed by qRT-PCR in the indicated DC populations generated as reported in Materials and Methods. Data are expressed as mean ± SD of 3 independent experiments. Mann-Whitney test was performed: *p=0.002, **p≤0.0001.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 MiR-23a and miR-125b quantification was carried out by qRT-PCR as reported in Material and Methods and fold changes of miRNA expression in the indicated DC populations obtained by 2 different donors (Don. A and Don. B) were calculated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sing GM-CSF-treated monocytes as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CasellaDiTesto 1880"/>
          <p:cNvSpPr/>
          <p:nvPr/>
        </p:nvSpPr>
        <p:spPr>
          <a:xfrm>
            <a:off x="2276640" y="363600"/>
            <a:ext cx="26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CasellaDiTesto 7"/>
          <p:cNvSpPr/>
          <p:nvPr/>
        </p:nvSpPr>
        <p:spPr>
          <a:xfrm>
            <a:off x="3770280" y="817560"/>
            <a:ext cx="3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CasellaDiTesto 7"/>
          <p:cNvSpPr/>
          <p:nvPr/>
        </p:nvSpPr>
        <p:spPr>
          <a:xfrm>
            <a:off x="4610160" y="814320"/>
            <a:ext cx="3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onnettore 1 8"/>
          <p:cNvSpPr/>
          <p:nvPr/>
        </p:nvSpPr>
        <p:spPr>
          <a:xfrm>
            <a:off x="3639960" y="973080"/>
            <a:ext cx="581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CasellaDiTesto 13"/>
          <p:cNvSpPr/>
          <p:nvPr/>
        </p:nvSpPr>
        <p:spPr>
          <a:xfrm>
            <a:off x="5021280" y="963720"/>
            <a:ext cx="27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Connettore 1 10"/>
          <p:cNvSpPr/>
          <p:nvPr/>
        </p:nvSpPr>
        <p:spPr>
          <a:xfrm>
            <a:off x="4483080" y="1119240"/>
            <a:ext cx="1268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onnettore 1 6"/>
          <p:cNvSpPr/>
          <p:nvPr/>
        </p:nvSpPr>
        <p:spPr>
          <a:xfrm>
            <a:off x="4481640" y="973080"/>
            <a:ext cx="577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621"/>
          <p:cNvSpPr/>
          <p:nvPr/>
        </p:nvSpPr>
        <p:spPr>
          <a:xfrm>
            <a:off x="3355920" y="2066760"/>
            <a:ext cx="339840" cy="6372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3622"/>
          <p:cNvSpPr/>
          <p:nvPr/>
        </p:nvSpPr>
        <p:spPr>
          <a:xfrm>
            <a:off x="4184640" y="1398600"/>
            <a:ext cx="331920" cy="73188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3623"/>
          <p:cNvSpPr/>
          <p:nvPr/>
        </p:nvSpPr>
        <p:spPr>
          <a:xfrm>
            <a:off x="5006880" y="1996920"/>
            <a:ext cx="339840" cy="13356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3624"/>
          <p:cNvSpPr/>
          <p:nvPr/>
        </p:nvSpPr>
        <p:spPr>
          <a:xfrm>
            <a:off x="5835600" y="1984320"/>
            <a:ext cx="331920" cy="146160"/>
          </a:xfrm>
          <a:prstGeom prst="rect">
            <a:avLst/>
          </a:prstGeom>
          <a:solidFill>
            <a:srgbClr val="96969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3625"/>
          <p:cNvSpPr/>
          <p:nvPr/>
        </p:nvSpPr>
        <p:spPr>
          <a:xfrm flipV="1">
            <a:off x="3522600" y="2060280"/>
            <a:ext cx="0" cy="6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3626"/>
          <p:cNvSpPr/>
          <p:nvPr/>
        </p:nvSpPr>
        <p:spPr>
          <a:xfrm>
            <a:off x="3498840" y="206064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3629"/>
          <p:cNvSpPr/>
          <p:nvPr/>
        </p:nvSpPr>
        <p:spPr>
          <a:xfrm flipV="1">
            <a:off x="5172120" y="1914120"/>
            <a:ext cx="0" cy="82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3630"/>
          <p:cNvSpPr/>
          <p:nvPr/>
        </p:nvSpPr>
        <p:spPr>
          <a:xfrm>
            <a:off x="5148360" y="1914480"/>
            <a:ext cx="55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3631"/>
          <p:cNvSpPr/>
          <p:nvPr/>
        </p:nvSpPr>
        <p:spPr>
          <a:xfrm flipV="1">
            <a:off x="6002280" y="1926720"/>
            <a:ext cx="0" cy="57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3632"/>
          <p:cNvSpPr/>
          <p:nvPr/>
        </p:nvSpPr>
        <p:spPr>
          <a:xfrm>
            <a:off x="5978520" y="1927080"/>
            <a:ext cx="55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3633"/>
          <p:cNvSpPr/>
          <p:nvPr/>
        </p:nvSpPr>
        <p:spPr>
          <a:xfrm>
            <a:off x="3522600" y="2066760"/>
            <a:ext cx="0" cy="6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3634"/>
          <p:cNvSpPr/>
          <p:nvPr/>
        </p:nvSpPr>
        <p:spPr>
          <a:xfrm>
            <a:off x="3498840" y="207324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Gruppo 149"/>
          <p:cNvGrpSpPr/>
          <p:nvPr/>
        </p:nvGrpSpPr>
        <p:grpSpPr>
          <a:xfrm>
            <a:off x="4327560" y="1212480"/>
            <a:ext cx="55440" cy="416160"/>
            <a:chOff x="4327560" y="1212480"/>
            <a:chExt cx="55440" cy="416160"/>
          </a:xfrm>
        </p:grpSpPr>
        <p:sp>
          <p:nvSpPr>
            <p:cNvPr id="63" name="Line 3627"/>
            <p:cNvSpPr/>
            <p:nvPr/>
          </p:nvSpPr>
          <p:spPr>
            <a:xfrm flipV="1">
              <a:off x="4351320" y="1212480"/>
              <a:ext cx="0" cy="207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628"/>
            <p:cNvSpPr/>
            <p:nvPr/>
          </p:nvSpPr>
          <p:spPr>
            <a:xfrm>
              <a:off x="4327560" y="1212840"/>
              <a:ext cx="55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635"/>
            <p:cNvSpPr/>
            <p:nvPr/>
          </p:nvSpPr>
          <p:spPr>
            <a:xfrm>
              <a:off x="4351320" y="1420560"/>
              <a:ext cx="0" cy="208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636"/>
            <p:cNvSpPr/>
            <p:nvPr/>
          </p:nvSpPr>
          <p:spPr>
            <a:xfrm>
              <a:off x="4327560" y="1628640"/>
              <a:ext cx="55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Line 3637"/>
          <p:cNvSpPr/>
          <p:nvPr/>
        </p:nvSpPr>
        <p:spPr>
          <a:xfrm>
            <a:off x="5172120" y="1996920"/>
            <a:ext cx="0" cy="763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638"/>
          <p:cNvSpPr/>
          <p:nvPr/>
        </p:nvSpPr>
        <p:spPr>
          <a:xfrm>
            <a:off x="5148360" y="2073240"/>
            <a:ext cx="55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639"/>
          <p:cNvSpPr/>
          <p:nvPr/>
        </p:nvSpPr>
        <p:spPr>
          <a:xfrm>
            <a:off x="6002280" y="1984320"/>
            <a:ext cx="0" cy="57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640"/>
          <p:cNvSpPr/>
          <p:nvPr/>
        </p:nvSpPr>
        <p:spPr>
          <a:xfrm>
            <a:off x="5978520" y="2041560"/>
            <a:ext cx="55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641"/>
          <p:cNvSpPr/>
          <p:nvPr/>
        </p:nvSpPr>
        <p:spPr>
          <a:xfrm>
            <a:off x="3111480" y="719280"/>
            <a:ext cx="0" cy="14112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642"/>
          <p:cNvSpPr/>
          <p:nvPr/>
        </p:nvSpPr>
        <p:spPr>
          <a:xfrm>
            <a:off x="3079800" y="213048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643"/>
          <p:cNvSpPr/>
          <p:nvPr/>
        </p:nvSpPr>
        <p:spPr>
          <a:xfrm>
            <a:off x="3079800" y="192708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644"/>
          <p:cNvSpPr/>
          <p:nvPr/>
        </p:nvSpPr>
        <p:spPr>
          <a:xfrm>
            <a:off x="3079800" y="173052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645"/>
          <p:cNvSpPr/>
          <p:nvPr/>
        </p:nvSpPr>
        <p:spPr>
          <a:xfrm>
            <a:off x="3079800" y="152712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646"/>
          <p:cNvSpPr/>
          <p:nvPr/>
        </p:nvSpPr>
        <p:spPr>
          <a:xfrm>
            <a:off x="3079800" y="132228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3647"/>
          <p:cNvSpPr/>
          <p:nvPr/>
        </p:nvSpPr>
        <p:spPr>
          <a:xfrm>
            <a:off x="3079800" y="111924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3648"/>
          <p:cNvSpPr/>
          <p:nvPr/>
        </p:nvSpPr>
        <p:spPr>
          <a:xfrm>
            <a:off x="3079800" y="92232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3649"/>
          <p:cNvSpPr/>
          <p:nvPr/>
        </p:nvSpPr>
        <p:spPr>
          <a:xfrm>
            <a:off x="3079800" y="719280"/>
            <a:ext cx="316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3650"/>
          <p:cNvSpPr/>
          <p:nvPr/>
        </p:nvSpPr>
        <p:spPr>
          <a:xfrm>
            <a:off x="3111480" y="2130480"/>
            <a:ext cx="33004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3651"/>
          <p:cNvSpPr/>
          <p:nvPr/>
        </p:nvSpPr>
        <p:spPr>
          <a:xfrm flipV="1">
            <a:off x="3111480" y="2130480"/>
            <a:ext cx="0" cy="252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3652"/>
          <p:cNvSpPr/>
          <p:nvPr/>
        </p:nvSpPr>
        <p:spPr>
          <a:xfrm flipV="1">
            <a:off x="3940200" y="2130480"/>
            <a:ext cx="0" cy="252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3653"/>
          <p:cNvSpPr/>
          <p:nvPr/>
        </p:nvSpPr>
        <p:spPr>
          <a:xfrm flipV="1">
            <a:off x="4762440" y="2130480"/>
            <a:ext cx="0" cy="252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3654"/>
          <p:cNvSpPr/>
          <p:nvPr/>
        </p:nvSpPr>
        <p:spPr>
          <a:xfrm flipV="1">
            <a:off x="5591160" y="2130480"/>
            <a:ext cx="0" cy="252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3655"/>
          <p:cNvSpPr/>
          <p:nvPr/>
        </p:nvSpPr>
        <p:spPr>
          <a:xfrm flipV="1">
            <a:off x="6411960" y="2130480"/>
            <a:ext cx="0" cy="252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3656"/>
          <p:cNvSpPr/>
          <p:nvPr/>
        </p:nvSpPr>
        <p:spPr>
          <a:xfrm>
            <a:off x="2976480" y="20797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3657"/>
          <p:cNvSpPr/>
          <p:nvPr/>
        </p:nvSpPr>
        <p:spPr>
          <a:xfrm>
            <a:off x="2836080" y="1876320"/>
            <a:ext cx="17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,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3658"/>
          <p:cNvSpPr/>
          <p:nvPr/>
        </p:nvSpPr>
        <p:spPr>
          <a:xfrm>
            <a:off x="2836080" y="1679400"/>
            <a:ext cx="17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,0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3659"/>
          <p:cNvSpPr/>
          <p:nvPr/>
        </p:nvSpPr>
        <p:spPr>
          <a:xfrm>
            <a:off x="2836080" y="1474920"/>
            <a:ext cx="17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,0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3660"/>
          <p:cNvSpPr/>
          <p:nvPr/>
        </p:nvSpPr>
        <p:spPr>
          <a:xfrm>
            <a:off x="2836080" y="1271520"/>
            <a:ext cx="17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,0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3661"/>
          <p:cNvSpPr/>
          <p:nvPr/>
        </p:nvSpPr>
        <p:spPr>
          <a:xfrm>
            <a:off x="2891160" y="106848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,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3662"/>
          <p:cNvSpPr/>
          <p:nvPr/>
        </p:nvSpPr>
        <p:spPr>
          <a:xfrm>
            <a:off x="2836080" y="871560"/>
            <a:ext cx="17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,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3663"/>
          <p:cNvSpPr/>
          <p:nvPr/>
        </p:nvSpPr>
        <p:spPr>
          <a:xfrm>
            <a:off x="2836080" y="668160"/>
            <a:ext cx="171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Arial"/>
              </a:rPr>
              <a:t>0,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3664"/>
          <p:cNvSpPr/>
          <p:nvPr/>
        </p:nvSpPr>
        <p:spPr>
          <a:xfrm>
            <a:off x="3283200" y="2200320"/>
            <a:ext cx="535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GM-CS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3665"/>
          <p:cNvSpPr/>
          <p:nvPr/>
        </p:nvSpPr>
        <p:spPr>
          <a:xfrm>
            <a:off x="4105800" y="2200320"/>
            <a:ext cx="57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IFN-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D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3666"/>
          <p:cNvSpPr/>
          <p:nvPr/>
        </p:nvSpPr>
        <p:spPr>
          <a:xfrm>
            <a:off x="4971960" y="2200320"/>
            <a:ext cx="43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IL-4 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3667"/>
          <p:cNvSpPr/>
          <p:nvPr/>
        </p:nvSpPr>
        <p:spPr>
          <a:xfrm>
            <a:off x="5581080" y="2200320"/>
            <a:ext cx="835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IL-4 DC+TNF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980"/>
          <p:cNvSpPr/>
          <p:nvPr/>
        </p:nvSpPr>
        <p:spPr>
          <a:xfrm rot="16200000">
            <a:off x="2196360" y="1125720"/>
            <a:ext cx="102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Blimp-1/β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" name="Gruppo 204"/>
          <p:cNvGrpSpPr/>
          <p:nvPr/>
        </p:nvGrpSpPr>
        <p:grpSpPr>
          <a:xfrm>
            <a:off x="1670760" y="2889360"/>
            <a:ext cx="2810880" cy="2410920"/>
            <a:chOff x="1670760" y="2889360"/>
            <a:chExt cx="2810880" cy="2410920"/>
          </a:xfrm>
        </p:grpSpPr>
        <p:sp>
          <p:nvSpPr>
            <p:cNvPr id="100" name="Rectangle 298"/>
            <p:cNvSpPr/>
            <p:nvPr/>
          </p:nvSpPr>
          <p:spPr>
            <a:xfrm>
              <a:off x="2062080" y="3953160"/>
              <a:ext cx="180720" cy="40608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299"/>
            <p:cNvSpPr/>
            <p:nvPr/>
          </p:nvSpPr>
          <p:spPr>
            <a:xfrm>
              <a:off x="2062080" y="3953160"/>
              <a:ext cx="180720" cy="40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300"/>
            <p:cNvSpPr/>
            <p:nvPr/>
          </p:nvSpPr>
          <p:spPr>
            <a:xfrm>
              <a:off x="2490480" y="3953160"/>
              <a:ext cx="171360" cy="129204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301"/>
            <p:cNvSpPr/>
            <p:nvPr/>
          </p:nvSpPr>
          <p:spPr>
            <a:xfrm>
              <a:off x="2490480" y="3953160"/>
              <a:ext cx="171360" cy="129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302"/>
            <p:cNvSpPr/>
            <p:nvPr/>
          </p:nvSpPr>
          <p:spPr>
            <a:xfrm>
              <a:off x="2909880" y="3953160"/>
              <a:ext cx="180720" cy="615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303"/>
            <p:cNvSpPr/>
            <p:nvPr/>
          </p:nvSpPr>
          <p:spPr>
            <a:xfrm>
              <a:off x="2909880" y="3953160"/>
              <a:ext cx="180720" cy="6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304"/>
            <p:cNvSpPr/>
            <p:nvPr/>
          </p:nvSpPr>
          <p:spPr>
            <a:xfrm>
              <a:off x="3338640" y="3953160"/>
              <a:ext cx="171360" cy="6156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305"/>
            <p:cNvSpPr/>
            <p:nvPr/>
          </p:nvSpPr>
          <p:spPr>
            <a:xfrm>
              <a:off x="3338640" y="3953160"/>
              <a:ext cx="171360" cy="6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306"/>
            <p:cNvSpPr/>
            <p:nvPr/>
          </p:nvSpPr>
          <p:spPr>
            <a:xfrm>
              <a:off x="3757680" y="3842280"/>
              <a:ext cx="180720" cy="11088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307"/>
            <p:cNvSpPr/>
            <p:nvPr/>
          </p:nvSpPr>
          <p:spPr>
            <a:xfrm>
              <a:off x="3757680" y="3842280"/>
              <a:ext cx="180720" cy="110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308"/>
            <p:cNvSpPr/>
            <p:nvPr/>
          </p:nvSpPr>
          <p:spPr>
            <a:xfrm>
              <a:off x="4186440" y="3953160"/>
              <a:ext cx="171360" cy="13140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309"/>
            <p:cNvSpPr/>
            <p:nvPr/>
          </p:nvSpPr>
          <p:spPr>
            <a:xfrm>
              <a:off x="4186440" y="3953160"/>
              <a:ext cx="171360" cy="131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310"/>
            <p:cNvSpPr/>
            <p:nvPr/>
          </p:nvSpPr>
          <p:spPr>
            <a:xfrm>
              <a:off x="1938240" y="3628080"/>
              <a:ext cx="0" cy="161748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311"/>
            <p:cNvSpPr/>
            <p:nvPr/>
          </p:nvSpPr>
          <p:spPr>
            <a:xfrm>
              <a:off x="1900080" y="5245560"/>
              <a:ext cx="37800" cy="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312"/>
            <p:cNvSpPr/>
            <p:nvPr/>
          </p:nvSpPr>
          <p:spPr>
            <a:xfrm>
              <a:off x="1900080" y="4920120"/>
              <a:ext cx="37800" cy="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313"/>
            <p:cNvSpPr/>
            <p:nvPr/>
          </p:nvSpPr>
          <p:spPr>
            <a:xfrm>
              <a:off x="1900080" y="4594680"/>
              <a:ext cx="37800" cy="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314"/>
            <p:cNvSpPr/>
            <p:nvPr/>
          </p:nvSpPr>
          <p:spPr>
            <a:xfrm>
              <a:off x="1900080" y="4278600"/>
              <a:ext cx="37800" cy="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315"/>
            <p:cNvSpPr/>
            <p:nvPr/>
          </p:nvSpPr>
          <p:spPr>
            <a:xfrm>
              <a:off x="1900080" y="3953160"/>
              <a:ext cx="37800" cy="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317"/>
            <p:cNvSpPr/>
            <p:nvPr/>
          </p:nvSpPr>
          <p:spPr>
            <a:xfrm>
              <a:off x="1938240" y="3953160"/>
              <a:ext cx="2543400" cy="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318"/>
            <p:cNvSpPr/>
            <p:nvPr/>
          </p:nvSpPr>
          <p:spPr>
            <a:xfrm flipV="1">
              <a:off x="1938240" y="3953160"/>
              <a:ext cx="0" cy="4104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320"/>
            <p:cNvSpPr/>
            <p:nvPr/>
          </p:nvSpPr>
          <p:spPr>
            <a:xfrm flipV="1">
              <a:off x="2786040" y="3953160"/>
              <a:ext cx="0" cy="4104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322"/>
            <p:cNvSpPr/>
            <p:nvPr/>
          </p:nvSpPr>
          <p:spPr>
            <a:xfrm flipV="1">
              <a:off x="3633840" y="3953160"/>
              <a:ext cx="0" cy="4104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324"/>
            <p:cNvSpPr/>
            <p:nvPr/>
          </p:nvSpPr>
          <p:spPr>
            <a:xfrm flipV="1">
              <a:off x="4481640" y="3953160"/>
              <a:ext cx="0" cy="4104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326"/>
            <p:cNvSpPr/>
            <p:nvPr/>
          </p:nvSpPr>
          <p:spPr>
            <a:xfrm>
              <a:off x="1670760" y="5162760"/>
              <a:ext cx="16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-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327"/>
            <p:cNvSpPr/>
            <p:nvPr/>
          </p:nvSpPr>
          <p:spPr>
            <a:xfrm>
              <a:off x="1670760" y="4837320"/>
              <a:ext cx="16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-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328"/>
            <p:cNvSpPr/>
            <p:nvPr/>
          </p:nvSpPr>
          <p:spPr>
            <a:xfrm>
              <a:off x="1670760" y="4511880"/>
              <a:ext cx="16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-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329"/>
            <p:cNvSpPr/>
            <p:nvPr/>
          </p:nvSpPr>
          <p:spPr>
            <a:xfrm>
              <a:off x="1737360" y="4197600"/>
              <a:ext cx="102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-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330"/>
            <p:cNvSpPr/>
            <p:nvPr/>
          </p:nvSpPr>
          <p:spPr>
            <a:xfrm>
              <a:off x="1775520" y="387252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331"/>
            <p:cNvSpPr/>
            <p:nvPr/>
          </p:nvSpPr>
          <p:spPr>
            <a:xfrm>
              <a:off x="1775520" y="35470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9" name="Gruppo 187"/>
            <p:cNvGrpSpPr/>
            <p:nvPr/>
          </p:nvGrpSpPr>
          <p:grpSpPr>
            <a:xfrm>
              <a:off x="2067480" y="3396600"/>
              <a:ext cx="2395440" cy="349920"/>
              <a:chOff x="2067480" y="3396600"/>
              <a:chExt cx="2395440" cy="349920"/>
            </a:xfrm>
          </p:grpSpPr>
          <p:sp>
            <p:nvSpPr>
              <p:cNvPr id="130" name="Rectangle 332"/>
              <p:cNvSpPr/>
              <p:nvPr/>
            </p:nvSpPr>
            <p:spPr>
              <a:xfrm rot="18306000">
                <a:off x="2044440" y="3510360"/>
                <a:ext cx="34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Don. A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Rectangle 333"/>
              <p:cNvSpPr/>
              <p:nvPr/>
            </p:nvSpPr>
            <p:spPr>
              <a:xfrm rot="18306000">
                <a:off x="2469960" y="3510360"/>
                <a:ext cx="31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Don. 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Rectangle 334"/>
              <p:cNvSpPr/>
              <p:nvPr/>
            </p:nvSpPr>
            <p:spPr>
              <a:xfrm rot="18306000">
                <a:off x="2892240" y="3510360"/>
                <a:ext cx="34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Don. A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Rectangle 335"/>
              <p:cNvSpPr/>
              <p:nvPr/>
            </p:nvSpPr>
            <p:spPr>
              <a:xfrm rot="18306000">
                <a:off x="3318120" y="3510360"/>
                <a:ext cx="31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Don. 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Rectangle 336"/>
              <p:cNvSpPr/>
              <p:nvPr/>
            </p:nvSpPr>
            <p:spPr>
              <a:xfrm rot="18306000">
                <a:off x="3740400" y="3510360"/>
                <a:ext cx="34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Don. A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337"/>
              <p:cNvSpPr/>
              <p:nvPr/>
            </p:nvSpPr>
            <p:spPr>
              <a:xfrm rot="18306000">
                <a:off x="4165920" y="3510360"/>
                <a:ext cx="31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800" spc="-1" strike="noStrike">
                    <a:solidFill>
                      <a:srgbClr val="000000"/>
                    </a:solidFill>
                    <a:latin typeface="Arial"/>
                  </a:rPr>
                  <a:t>Don. 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Line 316"/>
            <p:cNvSpPr/>
            <p:nvPr/>
          </p:nvSpPr>
          <p:spPr>
            <a:xfrm>
              <a:off x="1900080" y="3617640"/>
              <a:ext cx="37800" cy="0"/>
            </a:xfrm>
            <a:prstGeom prst="line">
              <a:avLst/>
            </a:prstGeom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7" name="Gruppo 196"/>
            <p:cNvGrpSpPr/>
            <p:nvPr/>
          </p:nvGrpSpPr>
          <p:grpSpPr>
            <a:xfrm>
              <a:off x="2064600" y="2889360"/>
              <a:ext cx="2379240" cy="420120"/>
              <a:chOff x="2064600" y="2889360"/>
              <a:chExt cx="2379240" cy="420120"/>
            </a:xfrm>
          </p:grpSpPr>
          <p:sp>
            <p:nvSpPr>
              <p:cNvPr id="138" name="Rectangle 325"/>
              <p:cNvSpPr/>
              <p:nvPr/>
            </p:nvSpPr>
            <p:spPr>
              <a:xfrm>
                <a:off x="2965680" y="2889360"/>
                <a:ext cx="5767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</a:rPr>
                  <a:t>miR-23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3665"/>
              <p:cNvSpPr/>
              <p:nvPr/>
            </p:nvSpPr>
            <p:spPr>
              <a:xfrm>
                <a:off x="2066040" y="3155400"/>
                <a:ext cx="5234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IFN-</a:t>
                </a:r>
                <a:r>
                  <a:rPr b="0" lang="en-GB" sz="9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 DC 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Rectangle 3666"/>
              <p:cNvSpPr/>
              <p:nvPr/>
            </p:nvSpPr>
            <p:spPr>
              <a:xfrm>
                <a:off x="3010680" y="3155400"/>
                <a:ext cx="3952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IL-4 D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Rectangle 3667"/>
              <p:cNvSpPr/>
              <p:nvPr/>
            </p:nvSpPr>
            <p:spPr>
              <a:xfrm>
                <a:off x="3687120" y="3155400"/>
                <a:ext cx="756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900" spc="-1" strike="noStrike">
                    <a:solidFill>
                      <a:srgbClr val="000000"/>
                    </a:solidFill>
                    <a:latin typeface="Arial"/>
                  </a:rPr>
                  <a:t>IL-4 DC+TNF</a:t>
                </a:r>
                <a:r>
                  <a:rPr b="0" lang="en-GB" sz="9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Connettore 1 169"/>
              <p:cNvSpPr/>
              <p:nvPr/>
            </p:nvSpPr>
            <p:spPr>
              <a:xfrm>
                <a:off x="2064600" y="3309480"/>
                <a:ext cx="581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Connettore 1 170"/>
              <p:cNvSpPr/>
              <p:nvPr/>
            </p:nvSpPr>
            <p:spPr>
              <a:xfrm>
                <a:off x="2920680" y="3309480"/>
                <a:ext cx="581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Connettore 1 171"/>
              <p:cNvSpPr/>
              <p:nvPr/>
            </p:nvSpPr>
            <p:spPr>
              <a:xfrm>
                <a:off x="3780000" y="3309480"/>
                <a:ext cx="581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Connettore 1 184"/>
              <p:cNvSpPr/>
              <p:nvPr/>
            </p:nvSpPr>
            <p:spPr>
              <a:xfrm>
                <a:off x="2064600" y="3084480"/>
                <a:ext cx="22960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46" name="Rectangle 249"/>
          <p:cNvSpPr/>
          <p:nvPr/>
        </p:nvSpPr>
        <p:spPr>
          <a:xfrm>
            <a:off x="5173560" y="3971880"/>
            <a:ext cx="181080" cy="28404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250"/>
          <p:cNvSpPr/>
          <p:nvPr/>
        </p:nvSpPr>
        <p:spPr>
          <a:xfrm>
            <a:off x="5173560" y="3971880"/>
            <a:ext cx="181080" cy="28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251"/>
          <p:cNvSpPr/>
          <p:nvPr/>
        </p:nvSpPr>
        <p:spPr>
          <a:xfrm>
            <a:off x="5611680" y="3971880"/>
            <a:ext cx="181080" cy="9036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252"/>
          <p:cNvSpPr/>
          <p:nvPr/>
        </p:nvSpPr>
        <p:spPr>
          <a:xfrm>
            <a:off x="5611680" y="3971880"/>
            <a:ext cx="181080" cy="9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253"/>
          <p:cNvSpPr/>
          <p:nvPr/>
        </p:nvSpPr>
        <p:spPr>
          <a:xfrm>
            <a:off x="6049800" y="3879720"/>
            <a:ext cx="181080" cy="9216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254"/>
          <p:cNvSpPr/>
          <p:nvPr/>
        </p:nvSpPr>
        <p:spPr>
          <a:xfrm>
            <a:off x="6049800" y="3879720"/>
            <a:ext cx="181080" cy="9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255"/>
          <p:cNvSpPr/>
          <p:nvPr/>
        </p:nvSpPr>
        <p:spPr>
          <a:xfrm>
            <a:off x="6488280" y="3778200"/>
            <a:ext cx="171360" cy="19368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256"/>
          <p:cNvSpPr/>
          <p:nvPr/>
        </p:nvSpPr>
        <p:spPr>
          <a:xfrm>
            <a:off x="6488280" y="3778200"/>
            <a:ext cx="171360" cy="19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257"/>
          <p:cNvSpPr/>
          <p:nvPr/>
        </p:nvSpPr>
        <p:spPr>
          <a:xfrm>
            <a:off x="6916680" y="3890880"/>
            <a:ext cx="181080" cy="8100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258"/>
          <p:cNvSpPr/>
          <p:nvPr/>
        </p:nvSpPr>
        <p:spPr>
          <a:xfrm>
            <a:off x="6916680" y="3890880"/>
            <a:ext cx="181080" cy="8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259"/>
          <p:cNvSpPr/>
          <p:nvPr/>
        </p:nvSpPr>
        <p:spPr>
          <a:xfrm>
            <a:off x="7354800" y="3798720"/>
            <a:ext cx="181080" cy="173160"/>
          </a:xfrm>
          <a:prstGeom prst="rect">
            <a:avLst/>
          </a:prstGeom>
          <a:solidFill>
            <a:srgbClr val="4f81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260"/>
          <p:cNvSpPr/>
          <p:nvPr/>
        </p:nvSpPr>
        <p:spPr>
          <a:xfrm>
            <a:off x="7354800" y="3798720"/>
            <a:ext cx="181080" cy="17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261"/>
          <p:cNvSpPr/>
          <p:nvPr/>
        </p:nvSpPr>
        <p:spPr>
          <a:xfrm>
            <a:off x="5049720" y="3646440"/>
            <a:ext cx="0" cy="160668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262"/>
          <p:cNvSpPr/>
          <p:nvPr/>
        </p:nvSpPr>
        <p:spPr>
          <a:xfrm>
            <a:off x="5011560" y="5253120"/>
            <a:ext cx="381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266"/>
          <p:cNvSpPr/>
          <p:nvPr/>
        </p:nvSpPr>
        <p:spPr>
          <a:xfrm>
            <a:off x="5011560" y="3971880"/>
            <a:ext cx="381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267"/>
          <p:cNvSpPr/>
          <p:nvPr/>
        </p:nvSpPr>
        <p:spPr>
          <a:xfrm>
            <a:off x="5011560" y="3646440"/>
            <a:ext cx="381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269"/>
          <p:cNvSpPr/>
          <p:nvPr/>
        </p:nvSpPr>
        <p:spPr>
          <a:xfrm flipV="1">
            <a:off x="5049720" y="3971880"/>
            <a:ext cx="0" cy="396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271"/>
          <p:cNvSpPr/>
          <p:nvPr/>
        </p:nvSpPr>
        <p:spPr>
          <a:xfrm flipV="1">
            <a:off x="5925960" y="3971880"/>
            <a:ext cx="0" cy="396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273"/>
          <p:cNvSpPr/>
          <p:nvPr/>
        </p:nvSpPr>
        <p:spPr>
          <a:xfrm flipV="1">
            <a:off x="6792840" y="3971880"/>
            <a:ext cx="0" cy="396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275"/>
          <p:cNvSpPr/>
          <p:nvPr/>
        </p:nvSpPr>
        <p:spPr>
          <a:xfrm flipV="1">
            <a:off x="7669080" y="3971880"/>
            <a:ext cx="0" cy="396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277"/>
          <p:cNvSpPr/>
          <p:nvPr/>
        </p:nvSpPr>
        <p:spPr>
          <a:xfrm>
            <a:off x="4782240" y="5181480"/>
            <a:ext cx="166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-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278"/>
          <p:cNvSpPr/>
          <p:nvPr/>
        </p:nvSpPr>
        <p:spPr>
          <a:xfrm>
            <a:off x="4782240" y="4856040"/>
            <a:ext cx="166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-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279"/>
          <p:cNvSpPr/>
          <p:nvPr/>
        </p:nvSpPr>
        <p:spPr>
          <a:xfrm>
            <a:off x="4782240" y="4541760"/>
            <a:ext cx="166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-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280"/>
          <p:cNvSpPr/>
          <p:nvPr/>
        </p:nvSpPr>
        <p:spPr>
          <a:xfrm>
            <a:off x="4849200" y="4216320"/>
            <a:ext cx="102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-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281"/>
          <p:cNvSpPr/>
          <p:nvPr/>
        </p:nvSpPr>
        <p:spPr>
          <a:xfrm>
            <a:off x="4887360" y="39006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282"/>
          <p:cNvSpPr/>
          <p:nvPr/>
        </p:nvSpPr>
        <p:spPr>
          <a:xfrm>
            <a:off x="4887360" y="3575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317"/>
          <p:cNvSpPr/>
          <p:nvPr/>
        </p:nvSpPr>
        <p:spPr>
          <a:xfrm>
            <a:off x="5057640" y="3968640"/>
            <a:ext cx="261936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276"/>
          <p:cNvSpPr/>
          <p:nvPr/>
        </p:nvSpPr>
        <p:spPr>
          <a:xfrm>
            <a:off x="6050520" y="2889360"/>
            <a:ext cx="662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R-125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4" name="Gruppo 181"/>
          <p:cNvGrpSpPr/>
          <p:nvPr/>
        </p:nvGrpSpPr>
        <p:grpSpPr>
          <a:xfrm>
            <a:off x="5175360" y="3156120"/>
            <a:ext cx="2378880" cy="153720"/>
            <a:chOff x="5175360" y="3156120"/>
            <a:chExt cx="2378880" cy="153720"/>
          </a:xfrm>
        </p:grpSpPr>
        <p:sp>
          <p:nvSpPr>
            <p:cNvPr id="175" name="Rectangle 3665"/>
            <p:cNvSpPr/>
            <p:nvPr/>
          </p:nvSpPr>
          <p:spPr>
            <a:xfrm>
              <a:off x="5177160" y="3156120"/>
              <a:ext cx="523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FN-</a:t>
              </a:r>
              <a:r>
                <a:rPr b="0" lang="en-GB" sz="9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 DC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3666"/>
            <p:cNvSpPr/>
            <p:nvPr/>
          </p:nvSpPr>
          <p:spPr>
            <a:xfrm>
              <a:off x="6121440" y="3156120"/>
              <a:ext cx="395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L-4 D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3667"/>
            <p:cNvSpPr/>
            <p:nvPr/>
          </p:nvSpPr>
          <p:spPr>
            <a:xfrm>
              <a:off x="6797520" y="3156120"/>
              <a:ext cx="756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IL-4 DC+TNF</a:t>
              </a:r>
              <a:r>
                <a:rPr b="0" lang="en-GB" sz="9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Connettore 1 177"/>
            <p:cNvSpPr/>
            <p:nvPr/>
          </p:nvSpPr>
          <p:spPr>
            <a:xfrm>
              <a:off x="5175360" y="3309840"/>
              <a:ext cx="581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Connettore 1 178"/>
            <p:cNvSpPr/>
            <p:nvPr/>
          </p:nvSpPr>
          <p:spPr>
            <a:xfrm>
              <a:off x="6030720" y="3309840"/>
              <a:ext cx="581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Connettore 1 179"/>
            <p:cNvSpPr/>
            <p:nvPr/>
          </p:nvSpPr>
          <p:spPr>
            <a:xfrm>
              <a:off x="6889680" y="3309840"/>
              <a:ext cx="581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1" name="Connettore 1 186"/>
          <p:cNvSpPr/>
          <p:nvPr/>
        </p:nvSpPr>
        <p:spPr>
          <a:xfrm>
            <a:off x="5187960" y="3084480"/>
            <a:ext cx="2293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2" name="Gruppo 197"/>
          <p:cNvGrpSpPr/>
          <p:nvPr/>
        </p:nvGrpSpPr>
        <p:grpSpPr>
          <a:xfrm>
            <a:off x="5226120" y="3395880"/>
            <a:ext cx="2394720" cy="349920"/>
            <a:chOff x="5226120" y="3395880"/>
            <a:chExt cx="2394720" cy="349920"/>
          </a:xfrm>
        </p:grpSpPr>
        <p:sp>
          <p:nvSpPr>
            <p:cNvPr id="183" name="Rectangle 332"/>
            <p:cNvSpPr/>
            <p:nvPr/>
          </p:nvSpPr>
          <p:spPr>
            <a:xfrm rot="18306000">
              <a:off x="5203080" y="3509640"/>
              <a:ext cx="34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Don. A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333"/>
            <p:cNvSpPr/>
            <p:nvPr/>
          </p:nvSpPr>
          <p:spPr>
            <a:xfrm rot="18306000">
              <a:off x="5628240" y="3510000"/>
              <a:ext cx="313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Don. 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334"/>
            <p:cNvSpPr/>
            <p:nvPr/>
          </p:nvSpPr>
          <p:spPr>
            <a:xfrm rot="18306000">
              <a:off x="6050520" y="3509640"/>
              <a:ext cx="34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Don. A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335"/>
            <p:cNvSpPr/>
            <p:nvPr/>
          </p:nvSpPr>
          <p:spPr>
            <a:xfrm rot="18306000">
              <a:off x="6476040" y="3510000"/>
              <a:ext cx="313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Don. 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336"/>
            <p:cNvSpPr/>
            <p:nvPr/>
          </p:nvSpPr>
          <p:spPr>
            <a:xfrm rot="18306000">
              <a:off x="6898320" y="3509640"/>
              <a:ext cx="34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Don. A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337"/>
            <p:cNvSpPr/>
            <p:nvPr/>
          </p:nvSpPr>
          <p:spPr>
            <a:xfrm rot="18306000">
              <a:off x="7323840" y="3510000"/>
              <a:ext cx="313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Don. 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9" name="Rectangle 1980"/>
          <p:cNvSpPr/>
          <p:nvPr/>
        </p:nvSpPr>
        <p:spPr>
          <a:xfrm rot="16200000">
            <a:off x="1061640" y="4152600"/>
            <a:ext cx="87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Fold chan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9T10:59:44Z</dcterms:created>
  <dc:creator>giulia</dc:creator>
  <dc:description/>
  <dc:language>en-US</dc:language>
  <cp:lastModifiedBy>gabriele_lucia</cp:lastModifiedBy>
  <dcterms:modified xsi:type="dcterms:W3CDTF">2013-08-05T13:18:44Z</dcterms:modified>
  <cp:revision>62</cp:revision>
  <dc:subject/>
  <dc:title>Diapositiva 1</dc:title>
</cp:coreProperties>
</file>